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35BD8-33A2-4C88-9F96-8AB0FC2C68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FCA4A-ABB8-4F3C-B216-06F97FEDD1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014A2-1727-4C2F-8AA5-56D0DBB975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2D3E6-2397-409A-B549-B02F9F37A8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6A65C-1BB3-4F66-8275-7CC198D1E8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2E4C46-6088-4515-B9AE-6F6267CDD4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E73DF-E68C-433C-ADD7-5351CC6464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C9E6F-90C9-4B4F-A5ED-AB68D95EE2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3E9A2-A2DE-4E11-B1D9-29FF7C5720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05525-F895-4529-A431-CE9BAA8C26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0D760-1425-4E85-8D43-43DF8E1718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23CE7-07D6-4D8D-8FC6-B7FAACDDCC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AB2287-2D7D-40EA-B4F9-3320BCBE10B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ounded Rectangle 5"/>
          <p:cNvSpPr/>
          <p:nvPr/>
        </p:nvSpPr>
        <p:spPr>
          <a:xfrm>
            <a:off x="457200" y="304920"/>
            <a:ext cx="2057400" cy="106668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838080" y="533520"/>
            <a:ext cx="1295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Calibri"/>
              </a:rPr>
              <a:t>Time 0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Oval 7"/>
          <p:cNvSpPr/>
          <p:nvPr/>
        </p:nvSpPr>
        <p:spPr>
          <a:xfrm>
            <a:off x="228600" y="1676520"/>
            <a:ext cx="2286000" cy="167616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8"/>
          <p:cNvSpPr/>
          <p:nvPr/>
        </p:nvSpPr>
        <p:spPr>
          <a:xfrm>
            <a:off x="609480" y="1981080"/>
            <a:ext cx="198144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Parotid mas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First-line blood tests negativ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Antibiotic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ight Arrow 9"/>
          <p:cNvSpPr/>
          <p:nvPr/>
        </p:nvSpPr>
        <p:spPr>
          <a:xfrm>
            <a:off x="2666880" y="609480"/>
            <a:ext cx="685800" cy="533520"/>
          </a:xfrm>
          <a:prstGeom prst="rightArrow">
            <a:avLst>
              <a:gd name="adj1" fmla="val 50000"/>
              <a:gd name="adj2" fmla="val 49989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ounded Rectangle 10"/>
          <p:cNvSpPr/>
          <p:nvPr/>
        </p:nvSpPr>
        <p:spPr>
          <a:xfrm>
            <a:off x="3429000" y="304920"/>
            <a:ext cx="1447920" cy="114300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3429000" y="604800"/>
            <a:ext cx="1447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Calibri"/>
              </a:rPr>
              <a:t>+ 11 days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Oval 12"/>
          <p:cNvSpPr/>
          <p:nvPr/>
        </p:nvSpPr>
        <p:spPr>
          <a:xfrm>
            <a:off x="3048120" y="1752480"/>
            <a:ext cx="2209680" cy="160020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3276720" y="2057400"/>
            <a:ext cx="19047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   </a:t>
            </a: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Admission at Pediatrics Ward for fever and pa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ounded Rectangle 14"/>
          <p:cNvSpPr/>
          <p:nvPr/>
        </p:nvSpPr>
        <p:spPr>
          <a:xfrm>
            <a:off x="5943600" y="304920"/>
            <a:ext cx="1447920" cy="121896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ight Arrow 15"/>
          <p:cNvSpPr/>
          <p:nvPr/>
        </p:nvSpPr>
        <p:spPr>
          <a:xfrm>
            <a:off x="5029200" y="685800"/>
            <a:ext cx="609480" cy="457200"/>
          </a:xfrm>
          <a:prstGeom prst="rightArrow">
            <a:avLst>
              <a:gd name="adj1" fmla="val 50000"/>
              <a:gd name="adj2" fmla="val 4999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6"/>
          <p:cNvSpPr/>
          <p:nvPr/>
        </p:nvSpPr>
        <p:spPr>
          <a:xfrm>
            <a:off x="6095880" y="533520"/>
            <a:ext cx="1143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Calibri"/>
              </a:rPr>
              <a:t>+18 day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Oval 17"/>
          <p:cNvSpPr/>
          <p:nvPr/>
        </p:nvSpPr>
        <p:spPr>
          <a:xfrm>
            <a:off x="5715000" y="1600200"/>
            <a:ext cx="2590920" cy="205740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8"/>
          <p:cNvSpPr/>
          <p:nvPr/>
        </p:nvSpPr>
        <p:spPr>
          <a:xfrm>
            <a:off x="6095880" y="1981080"/>
            <a:ext cx="221004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Laboratory  results inconclusiv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MRI: necrotic areas  in the lymphnodal mas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ight Arrow 19"/>
          <p:cNvSpPr/>
          <p:nvPr/>
        </p:nvSpPr>
        <p:spPr>
          <a:xfrm>
            <a:off x="7696080" y="685800"/>
            <a:ext cx="914400" cy="68580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ounded Rectangle 20"/>
          <p:cNvSpPr/>
          <p:nvPr/>
        </p:nvSpPr>
        <p:spPr>
          <a:xfrm>
            <a:off x="304920" y="3809880"/>
            <a:ext cx="2590560" cy="76212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1"/>
          <p:cNvSpPr/>
          <p:nvPr/>
        </p:nvSpPr>
        <p:spPr>
          <a:xfrm>
            <a:off x="457200" y="3943440"/>
            <a:ext cx="228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Calibri"/>
              </a:rPr>
              <a:t>+19 day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Oval 22"/>
          <p:cNvSpPr/>
          <p:nvPr/>
        </p:nvSpPr>
        <p:spPr>
          <a:xfrm>
            <a:off x="0" y="4648320"/>
            <a:ext cx="3276720" cy="205740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3"/>
          <p:cNvSpPr/>
          <p:nvPr/>
        </p:nvSpPr>
        <p:spPr>
          <a:xfrm>
            <a:off x="380880" y="4952880"/>
            <a:ext cx="259092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Biopsy : Emperipole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PCR  on the biopsy: EBV positive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Diagnosis : Rosai-Dorfman dise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ight Arrow 24"/>
          <p:cNvSpPr/>
          <p:nvPr/>
        </p:nvSpPr>
        <p:spPr>
          <a:xfrm>
            <a:off x="3048120" y="3886200"/>
            <a:ext cx="533160" cy="60948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ounded Rectangle 26"/>
          <p:cNvSpPr/>
          <p:nvPr/>
        </p:nvSpPr>
        <p:spPr>
          <a:xfrm>
            <a:off x="3809880" y="3809880"/>
            <a:ext cx="1524240" cy="76212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7"/>
          <p:cNvSpPr/>
          <p:nvPr/>
        </p:nvSpPr>
        <p:spPr>
          <a:xfrm>
            <a:off x="3733920" y="4019400"/>
            <a:ext cx="1523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Calibri"/>
              </a:rPr>
              <a:t>+20 day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Oval 28"/>
          <p:cNvSpPr/>
          <p:nvPr/>
        </p:nvSpPr>
        <p:spPr>
          <a:xfrm>
            <a:off x="3352680" y="4952880"/>
            <a:ext cx="2590920" cy="167652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9"/>
          <p:cNvSpPr/>
          <p:nvPr/>
        </p:nvSpPr>
        <p:spPr>
          <a:xfrm>
            <a:off x="3581280" y="5181480"/>
            <a:ext cx="213372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Prednisone for 40 days with progressive mass decreas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ight Arrow 31"/>
          <p:cNvSpPr/>
          <p:nvPr/>
        </p:nvSpPr>
        <p:spPr>
          <a:xfrm>
            <a:off x="5638680" y="3886200"/>
            <a:ext cx="762120" cy="457200"/>
          </a:xfrm>
          <a:prstGeom prst="rightArrow">
            <a:avLst>
              <a:gd name="adj1" fmla="val 50000"/>
              <a:gd name="adj2" fmla="val 50008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ounded Rectangle 33"/>
          <p:cNvSpPr/>
          <p:nvPr/>
        </p:nvSpPr>
        <p:spPr>
          <a:xfrm>
            <a:off x="6629400" y="3809880"/>
            <a:ext cx="2286000" cy="990720"/>
          </a:xfrm>
          <a:prstGeom prst="roundRect">
            <a:avLst>
              <a:gd name="adj" fmla="val 16667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4"/>
          <p:cNvSpPr/>
          <p:nvPr/>
        </p:nvSpPr>
        <p:spPr>
          <a:xfrm>
            <a:off x="6705720" y="3962520"/>
            <a:ext cx="2133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Calibri"/>
              </a:rPr>
              <a:t>+ 12 month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Oval 35"/>
          <p:cNvSpPr/>
          <p:nvPr/>
        </p:nvSpPr>
        <p:spPr>
          <a:xfrm>
            <a:off x="6629400" y="4952880"/>
            <a:ext cx="2286000" cy="1295640"/>
          </a:xfrm>
          <a:prstGeom prst="ellipse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6"/>
          <p:cNvSpPr/>
          <p:nvPr/>
        </p:nvSpPr>
        <p:spPr>
          <a:xfrm>
            <a:off x="6934320" y="5421240"/>
            <a:ext cx="167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No recurrenc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06T05:21:25Z</dcterms:created>
  <dc:creator>Dr. Hirsch</dc:creator>
  <dc:description/>
  <dc:language>en-US</dc:language>
  <cp:lastModifiedBy>Università di Modena</cp:lastModifiedBy>
  <dcterms:modified xsi:type="dcterms:W3CDTF">2016-04-08T10:20:05Z</dcterms:modified>
  <cp:revision>11</cp:revision>
  <dc:subject/>
  <dc:title>Slide 1</dc:title>
</cp:coreProperties>
</file>